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Default Extension="tiff" ContentType="image/tiff"/>
  <Default Extension="tif" ContentType="image/tiff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revisionInfo.xml" ContentType="application/vnd.ms-powerpoint.revisioninfo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notesMasterIdLst>
    <p:notesMasterId r:id="rId8"/>
  </p:notesMasterIdLst>
  <p:sldIdLst>
    <p:sldId id="281" r:id="rId5"/>
    <p:sldId id="295" r:id="rId6"/>
    <p:sldId id="296" r:id="rId7"/>
  </p:sldIdLst>
  <p:sldSz cx="7772400" cy="10058400"/>
  <p:notesSz cx="7010400" cy="9296400"/>
  <p:defaultTextStyle>
    <a:defPPr>
      <a:defRPr lang="en-US"/>
    </a:defPPr>
    <a:lvl1pPr marL="0" algn="l" defTabSz="1018824" rtl="0" eaLnBrk="1" latinLnBrk="0" hangingPunct="1">
      <a:defRPr sz="2006" kern="1200">
        <a:solidFill>
          <a:schemeClr val="tx1"/>
        </a:solidFill>
        <a:latin typeface="+mn-lt"/>
        <a:ea typeface="+mn-ea"/>
        <a:cs typeface="+mn-cs"/>
      </a:defRPr>
    </a:lvl1pPr>
    <a:lvl2pPr marL="509412" algn="l" defTabSz="1018824" rtl="0" eaLnBrk="1" latinLnBrk="0" hangingPunct="1">
      <a:defRPr sz="2006" kern="1200">
        <a:solidFill>
          <a:schemeClr val="tx1"/>
        </a:solidFill>
        <a:latin typeface="+mn-lt"/>
        <a:ea typeface="+mn-ea"/>
        <a:cs typeface="+mn-cs"/>
      </a:defRPr>
    </a:lvl2pPr>
    <a:lvl3pPr marL="1018824" algn="l" defTabSz="1018824" rtl="0" eaLnBrk="1" latinLnBrk="0" hangingPunct="1">
      <a:defRPr sz="2006" kern="1200">
        <a:solidFill>
          <a:schemeClr val="tx1"/>
        </a:solidFill>
        <a:latin typeface="+mn-lt"/>
        <a:ea typeface="+mn-ea"/>
        <a:cs typeface="+mn-cs"/>
      </a:defRPr>
    </a:lvl3pPr>
    <a:lvl4pPr marL="1528237" algn="l" defTabSz="1018824" rtl="0" eaLnBrk="1" latinLnBrk="0" hangingPunct="1">
      <a:defRPr sz="2006" kern="1200">
        <a:solidFill>
          <a:schemeClr val="tx1"/>
        </a:solidFill>
        <a:latin typeface="+mn-lt"/>
        <a:ea typeface="+mn-ea"/>
        <a:cs typeface="+mn-cs"/>
      </a:defRPr>
    </a:lvl4pPr>
    <a:lvl5pPr marL="2037649" algn="l" defTabSz="1018824" rtl="0" eaLnBrk="1" latinLnBrk="0" hangingPunct="1">
      <a:defRPr sz="2006" kern="1200">
        <a:solidFill>
          <a:schemeClr val="tx1"/>
        </a:solidFill>
        <a:latin typeface="+mn-lt"/>
        <a:ea typeface="+mn-ea"/>
        <a:cs typeface="+mn-cs"/>
      </a:defRPr>
    </a:lvl5pPr>
    <a:lvl6pPr marL="2547061" algn="l" defTabSz="1018824" rtl="0" eaLnBrk="1" latinLnBrk="0" hangingPunct="1">
      <a:defRPr sz="2006" kern="1200">
        <a:solidFill>
          <a:schemeClr val="tx1"/>
        </a:solidFill>
        <a:latin typeface="+mn-lt"/>
        <a:ea typeface="+mn-ea"/>
        <a:cs typeface="+mn-cs"/>
      </a:defRPr>
    </a:lvl6pPr>
    <a:lvl7pPr marL="3056473" algn="l" defTabSz="1018824" rtl="0" eaLnBrk="1" latinLnBrk="0" hangingPunct="1">
      <a:defRPr sz="2006" kern="1200">
        <a:solidFill>
          <a:schemeClr val="tx1"/>
        </a:solidFill>
        <a:latin typeface="+mn-lt"/>
        <a:ea typeface="+mn-ea"/>
        <a:cs typeface="+mn-cs"/>
      </a:defRPr>
    </a:lvl7pPr>
    <a:lvl8pPr marL="3565886" algn="l" defTabSz="1018824" rtl="0" eaLnBrk="1" latinLnBrk="0" hangingPunct="1">
      <a:defRPr sz="2006" kern="1200">
        <a:solidFill>
          <a:schemeClr val="tx1"/>
        </a:solidFill>
        <a:latin typeface="+mn-lt"/>
        <a:ea typeface="+mn-ea"/>
        <a:cs typeface="+mn-cs"/>
      </a:defRPr>
    </a:lvl8pPr>
    <a:lvl9pPr marL="4075298" algn="l" defTabSz="1018824" rtl="0" eaLnBrk="1" latinLnBrk="0" hangingPunct="1">
      <a:defRPr sz="2006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68" userDrawn="1">
          <p15:clr>
            <a:srgbClr val="A4A3A4"/>
          </p15:clr>
        </p15:guide>
        <p15:guide id="2" pos="2448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Savannah Sims" initials="SS" lastIdx="1" clrIdx="0">
    <p:extLst>
      <p:ext uri="{19B8F6BF-5375-455C-9EA6-DF929625EA0E}">
        <p15:presenceInfo xmlns:p15="http://schemas.microsoft.com/office/powerpoint/2012/main" userId="Savannah Sims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D4D4D4"/>
    <a:srgbClr val="BDD7EE"/>
    <a:srgbClr val="92C1FC"/>
    <a:srgbClr val="FE4040"/>
    <a:srgbClr val="002855"/>
    <a:srgbClr val="7C736A"/>
    <a:srgbClr val="EAAA00"/>
    <a:srgbClr val="808080"/>
    <a:srgbClr val="B07FC0"/>
    <a:srgbClr val="FAC09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E8B1032C-EA38-4F05-BA0D-38AFFFC7BED3}" styleName="Light Style 3 - Accent 6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6"/>
              </a:solidFill>
            </a:ln>
          </a:left>
          <a:right>
            <a:ln w="12700" cmpd="sng">
              <a:solidFill>
                <a:schemeClr val="accent6"/>
              </a:solidFill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 w="12700" cmpd="sng">
              <a:solidFill>
                <a:schemeClr val="accent6"/>
              </a:solidFill>
            </a:ln>
          </a:insideH>
          <a:insideV>
            <a:ln w="12700" cmpd="sng">
              <a:solidFill>
                <a:schemeClr val="accent6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6">
              <a:alpha val="20000"/>
            </a:schemeClr>
          </a:solidFill>
        </a:fill>
      </a:tcStyle>
    </a:band1H>
    <a:band1V>
      <a:tcStyle>
        <a:tcBdr/>
        <a:fill>
          <a:solidFill>
            <a:schemeClr val="accent6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6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6"/>
              </a:solidFill>
            </a:ln>
          </a:bottom>
        </a:tcBdr>
        <a:fill>
          <a:noFill/>
        </a:fill>
      </a:tcStyle>
    </a:firstRow>
  </a:tblStyle>
  <a:tblStyle styleId="{D7AC3CCA-C797-4891-BE02-D94E43425B78}" styleName="Medium Style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975" autoAdjust="0"/>
    <p:restoredTop sz="96370" autoAdjust="0"/>
  </p:normalViewPr>
  <p:slideViewPr>
    <p:cSldViewPr snapToGrid="0">
      <p:cViewPr>
        <p:scale>
          <a:sx n="100" d="100"/>
          <a:sy n="100" d="100"/>
        </p:scale>
        <p:origin x="2218" y="-566"/>
      </p:cViewPr>
      <p:guideLst>
        <p:guide orient="horz" pos="3168"/>
        <p:guide pos="2448"/>
      </p:guideLst>
    </p:cSldViewPr>
  </p:slideViewPr>
  <p:notesTextViewPr>
    <p:cViewPr>
      <p:scale>
        <a:sx n="3" d="2"/>
        <a:sy n="3" d="2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13" Type="http://schemas.openxmlformats.org/officeDocument/2006/relationships/tableStyles" Target="tableStyles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theme" Target="theme/theme1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viewProps" Target="viewProps.xml"/><Relationship Id="rId5" Type="http://schemas.openxmlformats.org/officeDocument/2006/relationships/slide" Target="slides/slide1.xml"/><Relationship Id="rId10" Type="http://schemas.openxmlformats.org/officeDocument/2006/relationships/presProps" Target="presProps.xml"/><Relationship Id="rId4" Type="http://schemas.openxmlformats.org/officeDocument/2006/relationships/slideMaster" Target="slideMasters/slideMaster1.xml"/><Relationship Id="rId9" Type="http://schemas.openxmlformats.org/officeDocument/2006/relationships/commentAuthors" Target="commentAuthors.xml"/><Relationship Id="rId22" Type="http://schemas.microsoft.com/office/2015/10/relationships/revisionInfo" Target="revisionInfo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1" y="3"/>
            <a:ext cx="3038649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134" y="3"/>
            <a:ext cx="3038648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3FEB61C-1BE2-4384-904A-3AC337BE1148}" type="datetimeFigureOut">
              <a:rPr lang="en-US" smtClean="0"/>
              <a:t>6/5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3938" y="1162050"/>
            <a:ext cx="2424112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848" y="4473578"/>
            <a:ext cx="5608320" cy="366077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1" y="8829678"/>
            <a:ext cx="3038649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134" y="8829678"/>
            <a:ext cx="3038648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AF18C8F-AB81-4C3C-8581-48FFC6EACC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205880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018824" rtl="0" eaLnBrk="1" latinLnBrk="0" hangingPunct="1">
      <a:defRPr sz="1337" kern="1200">
        <a:solidFill>
          <a:schemeClr val="tx1"/>
        </a:solidFill>
        <a:latin typeface="+mn-lt"/>
        <a:ea typeface="+mn-ea"/>
        <a:cs typeface="+mn-cs"/>
      </a:defRPr>
    </a:lvl1pPr>
    <a:lvl2pPr marL="509412" algn="l" defTabSz="1018824" rtl="0" eaLnBrk="1" latinLnBrk="0" hangingPunct="1">
      <a:defRPr sz="1337" kern="1200">
        <a:solidFill>
          <a:schemeClr val="tx1"/>
        </a:solidFill>
        <a:latin typeface="+mn-lt"/>
        <a:ea typeface="+mn-ea"/>
        <a:cs typeface="+mn-cs"/>
      </a:defRPr>
    </a:lvl2pPr>
    <a:lvl3pPr marL="1018824" algn="l" defTabSz="1018824" rtl="0" eaLnBrk="1" latinLnBrk="0" hangingPunct="1">
      <a:defRPr sz="1337" kern="1200">
        <a:solidFill>
          <a:schemeClr val="tx1"/>
        </a:solidFill>
        <a:latin typeface="+mn-lt"/>
        <a:ea typeface="+mn-ea"/>
        <a:cs typeface="+mn-cs"/>
      </a:defRPr>
    </a:lvl3pPr>
    <a:lvl4pPr marL="1528237" algn="l" defTabSz="1018824" rtl="0" eaLnBrk="1" latinLnBrk="0" hangingPunct="1">
      <a:defRPr sz="1337" kern="1200">
        <a:solidFill>
          <a:schemeClr val="tx1"/>
        </a:solidFill>
        <a:latin typeface="+mn-lt"/>
        <a:ea typeface="+mn-ea"/>
        <a:cs typeface="+mn-cs"/>
      </a:defRPr>
    </a:lvl4pPr>
    <a:lvl5pPr marL="2037649" algn="l" defTabSz="1018824" rtl="0" eaLnBrk="1" latinLnBrk="0" hangingPunct="1">
      <a:defRPr sz="1337" kern="1200">
        <a:solidFill>
          <a:schemeClr val="tx1"/>
        </a:solidFill>
        <a:latin typeface="+mn-lt"/>
        <a:ea typeface="+mn-ea"/>
        <a:cs typeface="+mn-cs"/>
      </a:defRPr>
    </a:lvl5pPr>
    <a:lvl6pPr marL="2547061" algn="l" defTabSz="1018824" rtl="0" eaLnBrk="1" latinLnBrk="0" hangingPunct="1">
      <a:defRPr sz="1337" kern="1200">
        <a:solidFill>
          <a:schemeClr val="tx1"/>
        </a:solidFill>
        <a:latin typeface="+mn-lt"/>
        <a:ea typeface="+mn-ea"/>
        <a:cs typeface="+mn-cs"/>
      </a:defRPr>
    </a:lvl6pPr>
    <a:lvl7pPr marL="3056473" algn="l" defTabSz="1018824" rtl="0" eaLnBrk="1" latinLnBrk="0" hangingPunct="1">
      <a:defRPr sz="1337" kern="1200">
        <a:solidFill>
          <a:schemeClr val="tx1"/>
        </a:solidFill>
        <a:latin typeface="+mn-lt"/>
        <a:ea typeface="+mn-ea"/>
        <a:cs typeface="+mn-cs"/>
      </a:defRPr>
    </a:lvl7pPr>
    <a:lvl8pPr marL="3565886" algn="l" defTabSz="1018824" rtl="0" eaLnBrk="1" latinLnBrk="0" hangingPunct="1">
      <a:defRPr sz="1337" kern="1200">
        <a:solidFill>
          <a:schemeClr val="tx1"/>
        </a:solidFill>
        <a:latin typeface="+mn-lt"/>
        <a:ea typeface="+mn-ea"/>
        <a:cs typeface="+mn-cs"/>
      </a:defRPr>
    </a:lvl8pPr>
    <a:lvl9pPr marL="4075298" algn="l" defTabSz="1018824" rtl="0" eaLnBrk="1" latinLnBrk="0" hangingPunct="1">
      <a:defRPr sz="1337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93938" y="1162050"/>
            <a:ext cx="2424112" cy="31369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AF18C8F-AB81-4C3C-8581-48FFC6EACC51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231877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3124626"/>
            <a:ext cx="6606540" cy="2156036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65860" y="5699760"/>
            <a:ext cx="5440680" cy="257048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5CEFE4-5865-44F7-8D8A-21113002787A}" type="datetimeFigureOut">
              <a:rPr lang="en-US" smtClean="0"/>
              <a:t>6/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E722C1-F212-4CF7-992B-EC1DCBAC22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23695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5CEFE4-5865-44F7-8D8A-21113002787A}" type="datetimeFigureOut">
              <a:rPr lang="en-US" smtClean="0"/>
              <a:t>6/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E722C1-F212-4CF7-992B-EC1DCBAC22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65220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634990" y="402804"/>
            <a:ext cx="1748790" cy="8582236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88620" y="402804"/>
            <a:ext cx="5116830" cy="858223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5CEFE4-5865-44F7-8D8A-21113002787A}" type="datetimeFigureOut">
              <a:rPr lang="en-US" smtClean="0"/>
              <a:t>6/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E722C1-F212-4CF7-992B-EC1DCBAC22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6996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5CEFE4-5865-44F7-8D8A-21113002787A}" type="datetimeFigureOut">
              <a:rPr lang="en-US" smtClean="0"/>
              <a:t>6/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E722C1-F212-4CF7-992B-EC1DCBAC22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61178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3966" y="6463454"/>
            <a:ext cx="6606540" cy="199771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3966" y="4263180"/>
            <a:ext cx="6606540" cy="2200274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5CEFE4-5865-44F7-8D8A-21113002787A}" type="datetimeFigureOut">
              <a:rPr lang="en-US" smtClean="0"/>
              <a:t>6/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E722C1-F212-4CF7-992B-EC1DCBAC22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04312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88620" y="2346962"/>
            <a:ext cx="3432810" cy="6638079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50970" y="2346962"/>
            <a:ext cx="3432810" cy="6638079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5CEFE4-5865-44F7-8D8A-21113002787A}" type="datetimeFigureOut">
              <a:rPr lang="en-US" smtClean="0"/>
              <a:t>6/5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E722C1-F212-4CF7-992B-EC1DCBAC22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23894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88620" y="2251499"/>
            <a:ext cx="3434160" cy="938318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8620" y="3189817"/>
            <a:ext cx="3434160" cy="579522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48272" y="2251499"/>
            <a:ext cx="3435508" cy="938318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48272" y="3189817"/>
            <a:ext cx="3435508" cy="579522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5CEFE4-5865-44F7-8D8A-21113002787A}" type="datetimeFigureOut">
              <a:rPr lang="en-US" smtClean="0"/>
              <a:t>6/5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E722C1-F212-4CF7-992B-EC1DCBAC22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11947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5CEFE4-5865-44F7-8D8A-21113002787A}" type="datetimeFigureOut">
              <a:rPr lang="en-US" smtClean="0"/>
              <a:t>6/5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E722C1-F212-4CF7-992B-EC1DCBAC22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90272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5CEFE4-5865-44F7-8D8A-21113002787A}" type="datetimeFigureOut">
              <a:rPr lang="en-US" smtClean="0"/>
              <a:t>6/5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E722C1-F212-4CF7-992B-EC1DCBAC22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15177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88621" y="400474"/>
            <a:ext cx="2557066" cy="170434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038793" y="400474"/>
            <a:ext cx="4344988" cy="8584566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88621" y="2104814"/>
            <a:ext cx="2557066" cy="6880226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5CEFE4-5865-44F7-8D8A-21113002787A}" type="datetimeFigureOut">
              <a:rPr lang="en-US" smtClean="0"/>
              <a:t>6/5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E722C1-F212-4CF7-992B-EC1DCBAC22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12127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523445" y="7040881"/>
            <a:ext cx="4663440" cy="831216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523445" y="898736"/>
            <a:ext cx="4663440" cy="603504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523445" y="7872097"/>
            <a:ext cx="4663440" cy="1180464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5CEFE4-5865-44F7-8D8A-21113002787A}" type="datetimeFigureOut">
              <a:rPr lang="en-US" smtClean="0"/>
              <a:t>6/5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E722C1-F212-4CF7-992B-EC1DCBAC22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61053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88620" y="402802"/>
            <a:ext cx="6995160" cy="16764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88620" y="2346962"/>
            <a:ext cx="6995160" cy="663807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88620" y="9322648"/>
            <a:ext cx="1813560" cy="53551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5CEFE4-5865-44F7-8D8A-21113002787A}" type="datetimeFigureOut">
              <a:rPr lang="en-US" smtClean="0"/>
              <a:t>6/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655570" y="9322648"/>
            <a:ext cx="2461260" cy="53551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570220" y="9322648"/>
            <a:ext cx="1813560" cy="53551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E722C1-F212-4CF7-992B-EC1DCBAC22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47965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hyperlink" Target="JAK1-dependent%20genes%20for%20figure%20S1.xlsx" TargetMode="Externa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5" name="Straight Connector 4">
            <a:extLst>
              <a:ext uri="{FF2B5EF4-FFF2-40B4-BE49-F238E27FC236}">
                <a16:creationId xmlns:a16="http://schemas.microsoft.com/office/drawing/2014/main" id="{7B905502-9522-4DE7-B3CC-0F05B1B914F7}"/>
              </a:ext>
            </a:extLst>
          </p:cNvPr>
          <p:cNvCxnSpPr/>
          <p:nvPr/>
        </p:nvCxnSpPr>
        <p:spPr>
          <a:xfrm>
            <a:off x="457200" y="457200"/>
            <a:ext cx="914400" cy="0"/>
          </a:xfrm>
          <a:prstGeom prst="line">
            <a:avLst/>
          </a:prstGeom>
          <a:ln w="0" cap="flat" cmpd="sng" algn="ctr">
            <a:solidFill>
              <a:srgbClr val="FBFFFF"/>
            </a:solidFill>
            <a:prstDash val="solid"/>
            <a:round/>
            <a:headEnd type="none" w="med" len="med"/>
            <a:tailEnd type="none" w="med" len="med"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blurRad="63500" rotWithShape="0">
                    <a:scrgbClr r="0" g="0" b="0"/>
                  </a:outerShdw>
                </a:effectLst>
              </a14:hiddenEffects>
            </a:ext>
          </a:extLst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TextBox 1">
            <a:extLst>
              <a:ext uri="{FF2B5EF4-FFF2-40B4-BE49-F238E27FC236}">
                <a16:creationId xmlns:a16="http://schemas.microsoft.com/office/drawing/2014/main" id="{90E18CA6-3540-4CBA-86AD-70E5AC5AD462}"/>
              </a:ext>
            </a:extLst>
          </p:cNvPr>
          <p:cNvSpPr txBox="1"/>
          <p:nvPr/>
        </p:nvSpPr>
        <p:spPr>
          <a:xfrm>
            <a:off x="99491" y="329700"/>
            <a:ext cx="18133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l Figure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. </a:t>
            </a:r>
          </a:p>
        </p:txBody>
      </p:sp>
      <p:sp>
        <p:nvSpPr>
          <p:cNvPr id="6" name="TextBox 5">
            <a:hlinkClick r:id="rId3" action="ppaction://hlinkfile"/>
            <a:extLst>
              <a:ext uri="{FF2B5EF4-FFF2-40B4-BE49-F238E27FC236}">
                <a16:creationId xmlns:a16="http://schemas.microsoft.com/office/drawing/2014/main" id="{C801ED18-86C2-4DB0-B580-8817847F0C2A}"/>
              </a:ext>
            </a:extLst>
          </p:cNvPr>
          <p:cNvSpPr txBox="1"/>
          <p:nvPr/>
        </p:nvSpPr>
        <p:spPr>
          <a:xfrm>
            <a:off x="1620196" y="707824"/>
            <a:ext cx="5025735" cy="4010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JAK1-dependent ER stress induced genes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796981" y="1012400"/>
            <a:ext cx="2852928" cy="553998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algn="ctr"/>
            <a:r>
              <a:rPr lang="en-US" sz="1500" dirty="0">
                <a:latin typeface="Arial" panose="020B0604020202020204" pitchFamily="34" charset="0"/>
                <a:cs typeface="Arial" panose="020B0604020202020204" pitchFamily="34" charset="0"/>
              </a:rPr>
              <a:t>Control siRNA vs. Control siRNA </a:t>
            </a:r>
            <a:r>
              <a:rPr lang="en-US" sz="1500" dirty="0" err="1">
                <a:latin typeface="Arial" panose="020B0604020202020204" pitchFamily="34" charset="0"/>
                <a:cs typeface="Arial" panose="020B0604020202020204" pitchFamily="34" charset="0"/>
              </a:rPr>
              <a:t>Thaps</a:t>
            </a:r>
            <a:endParaRPr lang="en-US" sz="1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4140362" y="1012400"/>
            <a:ext cx="2852928" cy="553998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algn="ctr"/>
            <a:r>
              <a:rPr lang="en-US" sz="1500" dirty="0">
                <a:latin typeface="Arial" panose="020B0604020202020204" pitchFamily="34" charset="0"/>
                <a:cs typeface="Arial" panose="020B0604020202020204" pitchFamily="34" charset="0"/>
              </a:rPr>
              <a:t>Control siRNA </a:t>
            </a:r>
            <a:r>
              <a:rPr lang="en-US" sz="1500" dirty="0" err="1">
                <a:latin typeface="Arial" panose="020B0604020202020204" pitchFamily="34" charset="0"/>
                <a:cs typeface="Arial" panose="020B0604020202020204" pitchFamily="34" charset="0"/>
              </a:rPr>
              <a:t>Thaps</a:t>
            </a:r>
            <a:r>
              <a:rPr lang="en-US" sz="1500" dirty="0">
                <a:latin typeface="Arial" panose="020B0604020202020204" pitchFamily="34" charset="0"/>
                <a:cs typeface="Arial" panose="020B0604020202020204" pitchFamily="34" charset="0"/>
              </a:rPr>
              <a:t> vs. JAK1 siRNA </a:t>
            </a:r>
            <a:r>
              <a:rPr lang="en-US" sz="1500" dirty="0" err="1">
                <a:latin typeface="Arial" panose="020B0604020202020204" pitchFamily="34" charset="0"/>
                <a:cs typeface="Arial" panose="020B0604020202020204" pitchFamily="34" charset="0"/>
              </a:rPr>
              <a:t>Thaps</a:t>
            </a:r>
            <a:r>
              <a:rPr lang="en-US" sz="1500" dirty="0">
                <a:latin typeface="Arial" panose="020B0604020202020204" pitchFamily="34" charset="0"/>
                <a:cs typeface="Arial" panose="020B0604020202020204" pitchFamily="34" charset="0"/>
              </a:rPr>
              <a:t> </a:t>
            </a:r>
          </a:p>
        </p:txBody>
      </p:sp>
      <p:sp>
        <p:nvSpPr>
          <p:cNvPr id="3" name="Rectangle 2"/>
          <p:cNvSpPr/>
          <p:nvPr/>
        </p:nvSpPr>
        <p:spPr>
          <a:xfrm>
            <a:off x="455003" y="9153227"/>
            <a:ext cx="6858000" cy="4308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l Figure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1: JAK1-dependent ER stress induced genes.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Top 50 ER stress induced genes and full gene list of genes induced by ER stress in a JAK1-dependent fashion. </a:t>
            </a:r>
          </a:p>
        </p:txBody>
      </p:sp>
      <p:graphicFrame>
        <p:nvGraphicFramePr>
          <p:cNvPr id="9" name="Table 8">
            <a:extLst>
              <a:ext uri="{FF2B5EF4-FFF2-40B4-BE49-F238E27FC236}">
                <a16:creationId xmlns:a16="http://schemas.microsoft.com/office/drawing/2014/main" id="{E697673C-A23B-4740-BA0D-52CC62E19AB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64387026"/>
              </p:ext>
            </p:extLst>
          </p:nvPr>
        </p:nvGraphicFramePr>
        <p:xfrm>
          <a:off x="628012" y="1513647"/>
          <a:ext cx="3200399" cy="7653509"/>
        </p:xfrm>
        <a:graphic>
          <a:graphicData uri="http://schemas.openxmlformats.org/drawingml/2006/table">
            <a:tbl>
              <a:tblPr/>
              <a:tblGrid>
                <a:gridCol w="579695">
                  <a:extLst>
                    <a:ext uri="{9D8B030D-6E8A-4147-A177-3AD203B41FA5}">
                      <a16:colId xmlns:a16="http://schemas.microsoft.com/office/drawing/2014/main" val="2146112592"/>
                    </a:ext>
                  </a:extLst>
                </a:gridCol>
                <a:gridCol w="579695">
                  <a:extLst>
                    <a:ext uri="{9D8B030D-6E8A-4147-A177-3AD203B41FA5}">
                      <a16:colId xmlns:a16="http://schemas.microsoft.com/office/drawing/2014/main" val="2240383351"/>
                    </a:ext>
                  </a:extLst>
                </a:gridCol>
                <a:gridCol w="881619">
                  <a:extLst>
                    <a:ext uri="{9D8B030D-6E8A-4147-A177-3AD203B41FA5}">
                      <a16:colId xmlns:a16="http://schemas.microsoft.com/office/drawing/2014/main" val="3208266622"/>
                    </a:ext>
                  </a:extLst>
                </a:gridCol>
                <a:gridCol w="579695">
                  <a:extLst>
                    <a:ext uri="{9D8B030D-6E8A-4147-A177-3AD203B41FA5}">
                      <a16:colId xmlns:a16="http://schemas.microsoft.com/office/drawing/2014/main" val="2139277223"/>
                    </a:ext>
                  </a:extLst>
                </a:gridCol>
                <a:gridCol w="579695">
                  <a:extLst>
                    <a:ext uri="{9D8B030D-6E8A-4147-A177-3AD203B41FA5}">
                      <a16:colId xmlns:a16="http://schemas.microsoft.com/office/drawing/2014/main" val="2300529485"/>
                    </a:ext>
                  </a:extLst>
                </a:gridCol>
              </a:tblGrid>
              <a:tr h="341709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ene Name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C0C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old Change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C0C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EDGE Test P Value 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C0C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Untreated - Means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C0C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haps - Means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C0C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74467326"/>
                  </a:ext>
                </a:extLst>
              </a:tr>
              <a:tr h="14623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gf21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97.31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.80E-04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1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.57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22072662"/>
                  </a:ext>
                </a:extLst>
              </a:tr>
              <a:tr h="14623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rib3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99.72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.11E-33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18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5.06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42312948"/>
                  </a:ext>
                </a:extLst>
              </a:tr>
              <a:tr h="14623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hac1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94.46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55E-112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84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63.42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80634638"/>
                  </a:ext>
                </a:extLst>
              </a:tr>
              <a:tr h="14623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dm2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9.5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.81E-03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3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.62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39364978"/>
                  </a:ext>
                </a:extLst>
              </a:tr>
              <a:tr h="14623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cl20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4.72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.91E-03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4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.95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78320089"/>
                  </a:ext>
                </a:extLst>
              </a:tr>
              <a:tr h="14623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tgs2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1.5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.33E-13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23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3.84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82160451"/>
                  </a:ext>
                </a:extLst>
              </a:tr>
              <a:tr h="14623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cl7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0.43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.41E-07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15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.43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93249203"/>
                  </a:ext>
                </a:extLst>
              </a:tr>
              <a:tr h="14623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erpud1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2.19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.47E-117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.05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28.76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1586882"/>
                  </a:ext>
                </a:extLst>
              </a:tr>
              <a:tr h="14623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cl2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7.87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.75E-25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07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9.7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98625839"/>
                  </a:ext>
                </a:extLst>
              </a:tr>
              <a:tr h="14623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sns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6.81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.55E-13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56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5.11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22940007"/>
                  </a:ext>
                </a:extLst>
              </a:tr>
              <a:tr h="14623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xcl1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6.54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.13E-02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8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.03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64521272"/>
                  </a:ext>
                </a:extLst>
              </a:tr>
              <a:tr h="14623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dit3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6.03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.24E-83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.61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3.87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75404267"/>
                  </a:ext>
                </a:extLst>
              </a:tr>
              <a:tr h="14623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yt4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4.75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56E-02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9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.23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7454709"/>
                  </a:ext>
                </a:extLst>
              </a:tr>
              <a:tr h="14623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erl3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2.31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.70E-11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56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2.5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83981004"/>
                  </a:ext>
                </a:extLst>
              </a:tr>
              <a:tr h="14623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thfd2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9.31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10E-09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59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1.32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71935656"/>
                  </a:ext>
                </a:extLst>
              </a:tr>
              <a:tr h="14623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lc7a1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7.87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.22E-07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47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.31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96897440"/>
                  </a:ext>
                </a:extLst>
              </a:tr>
              <a:tr h="14623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xcl10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7.29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98E-80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.55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5.98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57644449"/>
                  </a:ext>
                </a:extLst>
              </a:tr>
              <a:tr h="14623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df2l1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6.1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.18E-73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.85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10.27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29222874"/>
                  </a:ext>
                </a:extLst>
              </a:tr>
              <a:tr h="14623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tf3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4.77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17E-02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22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.22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51853057"/>
                  </a:ext>
                </a:extLst>
              </a:tr>
              <a:tr h="14623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ist1h3a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4.16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.13E-02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14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94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88531013"/>
                  </a:ext>
                </a:extLst>
              </a:tr>
              <a:tr h="14623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reld2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4.11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59E-53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.61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5.03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91518596"/>
                  </a:ext>
                </a:extLst>
              </a:tr>
              <a:tr h="14623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Zfp57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3.38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56E-02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16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.12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06794940"/>
                  </a:ext>
                </a:extLst>
              </a:tr>
              <a:tr h="14623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mem74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3.07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.81E-03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2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.62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61122566"/>
                  </a:ext>
                </a:extLst>
              </a:tr>
              <a:tr h="14623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tc2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2.42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.13E-02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14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79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37607501"/>
                  </a:ext>
                </a:extLst>
              </a:tr>
              <a:tr h="14623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tf4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2.05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.50E-53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4.54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16.19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77956792"/>
                  </a:ext>
                </a:extLst>
              </a:tr>
              <a:tr h="14623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iart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1.8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.07E-06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71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.38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3007405"/>
                  </a:ext>
                </a:extLst>
              </a:tr>
              <a:tr h="14623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pp1r15a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1.13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.88E-77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.88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8.84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92114808"/>
                  </a:ext>
                </a:extLst>
              </a:tr>
              <a:tr h="14623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iga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1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.07E-09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15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2.65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4168254"/>
                  </a:ext>
                </a:extLst>
              </a:tr>
              <a:tr h="14623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ist1h1a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0.81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.69E-07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86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.32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44627962"/>
                  </a:ext>
                </a:extLst>
              </a:tr>
              <a:tr h="14623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th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0.79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.91E-02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23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.47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18656893"/>
                  </a:ext>
                </a:extLst>
              </a:tr>
              <a:tr h="14623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2-K2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0.17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.13E-02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18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86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85107187"/>
                  </a:ext>
                </a:extLst>
              </a:tr>
              <a:tr h="14623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add45a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0.11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.19E-80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1.54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16.63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78408382"/>
                  </a:ext>
                </a:extLst>
              </a:tr>
              <a:tr h="14623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you1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.79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.03E-75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0.07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8.54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51329067"/>
                  </a:ext>
                </a:extLst>
              </a:tr>
              <a:tr h="14623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ist1h1d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.75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07E-26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.23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1.21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58276335"/>
                  </a:ext>
                </a:extLst>
              </a:tr>
              <a:tr h="14623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fil3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.62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.69E-07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6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.23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8816042"/>
                  </a:ext>
                </a:extLst>
              </a:tr>
              <a:tr h="14623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tard4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.48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.44E-17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.75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6.12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24522597"/>
                  </a:ext>
                </a:extLst>
              </a:tr>
              <a:tr h="14623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Egr2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.24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.15E-02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3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.8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31939464"/>
                  </a:ext>
                </a:extLst>
              </a:tr>
              <a:tr h="14623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ist1h1b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.15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.65E-26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.44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0.62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93476500"/>
                  </a:ext>
                </a:extLst>
              </a:tr>
              <a:tr h="14623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Xbp1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.88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.57E-60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.01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0.01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45357046"/>
                  </a:ext>
                </a:extLst>
              </a:tr>
              <a:tr h="14623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ist1h2bj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.5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.04E-48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.36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1.12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99469629"/>
                  </a:ext>
                </a:extLst>
              </a:tr>
              <a:tr h="14623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gs16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.28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.51E-52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.53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0.63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40323842"/>
                  </a:ext>
                </a:extLst>
              </a:tr>
              <a:tr h="14623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spa5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.27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14E-93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47.53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219.56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43721121"/>
                  </a:ext>
                </a:extLst>
              </a:tr>
              <a:tr h="14623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lc7a5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.26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04E-07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45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1.99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57874877"/>
                  </a:ext>
                </a:extLst>
              </a:tr>
              <a:tr h="14623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upr1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.1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.38E-09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83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4.85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73425808"/>
                  </a:ext>
                </a:extLst>
              </a:tr>
              <a:tr h="14623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r4a1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.94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.15E-02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35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.81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06599525"/>
                  </a:ext>
                </a:extLst>
              </a:tr>
              <a:tr h="14623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srnp1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.77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.24E-07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32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0.28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71550908"/>
                  </a:ext>
                </a:extLst>
              </a:tr>
              <a:tr h="14623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vd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.68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73E-08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66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2.78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3595938"/>
                  </a:ext>
                </a:extLst>
              </a:tr>
              <a:tr h="14623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Vldlr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.67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.05E-04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75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.73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34718617"/>
                  </a:ext>
                </a:extLst>
              </a:tr>
              <a:tr h="14623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emip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.66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17E-02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43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.33</a:t>
                      </a:r>
                    </a:p>
                  </a:txBody>
                  <a:tcPr marL="4800" marR="4800" marT="48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02778227"/>
                  </a:ext>
                </a:extLst>
              </a:tr>
              <a:tr h="146236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ck2</a:t>
                      </a:r>
                    </a:p>
                  </a:txBody>
                  <a:tcPr marL="4800" marR="4800" marT="48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.64</a:t>
                      </a:r>
                    </a:p>
                  </a:txBody>
                  <a:tcPr marL="4800" marR="4800" marT="48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.20E-10</a:t>
                      </a:r>
                    </a:p>
                  </a:txBody>
                  <a:tcPr marL="4800" marR="4800" marT="48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.16</a:t>
                      </a:r>
                    </a:p>
                  </a:txBody>
                  <a:tcPr marL="4800" marR="4800" marT="48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6.5</a:t>
                      </a:r>
                    </a:p>
                  </a:txBody>
                  <a:tcPr marL="4800" marR="4800" marT="48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45402034"/>
                  </a:ext>
                </a:extLst>
              </a:tr>
            </a:tbl>
          </a:graphicData>
        </a:graphic>
      </p:graphicFrame>
      <p:graphicFrame>
        <p:nvGraphicFramePr>
          <p:cNvPr id="11" name="Table 10">
            <a:extLst>
              <a:ext uri="{FF2B5EF4-FFF2-40B4-BE49-F238E27FC236}">
                <a16:creationId xmlns:a16="http://schemas.microsoft.com/office/drawing/2014/main" id="{D49D4FAD-D820-4BC3-A5D2-BFCFD98705B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31911488"/>
              </p:ext>
            </p:extLst>
          </p:nvPr>
        </p:nvGraphicFramePr>
        <p:xfrm>
          <a:off x="3966626" y="1513646"/>
          <a:ext cx="3200401" cy="7651560"/>
        </p:xfrm>
        <a:graphic>
          <a:graphicData uri="http://schemas.openxmlformats.org/drawingml/2006/table">
            <a:tbl>
              <a:tblPr/>
              <a:tblGrid>
                <a:gridCol w="604800">
                  <a:extLst>
                    <a:ext uri="{9D8B030D-6E8A-4147-A177-3AD203B41FA5}">
                      <a16:colId xmlns:a16="http://schemas.microsoft.com/office/drawing/2014/main" val="1555609976"/>
                    </a:ext>
                  </a:extLst>
                </a:gridCol>
                <a:gridCol w="604800">
                  <a:extLst>
                    <a:ext uri="{9D8B030D-6E8A-4147-A177-3AD203B41FA5}">
                      <a16:colId xmlns:a16="http://schemas.microsoft.com/office/drawing/2014/main" val="684781482"/>
                    </a:ext>
                  </a:extLst>
                </a:gridCol>
                <a:gridCol w="781201">
                  <a:extLst>
                    <a:ext uri="{9D8B030D-6E8A-4147-A177-3AD203B41FA5}">
                      <a16:colId xmlns:a16="http://schemas.microsoft.com/office/drawing/2014/main" val="437461"/>
                    </a:ext>
                  </a:extLst>
                </a:gridCol>
                <a:gridCol w="604800">
                  <a:extLst>
                    <a:ext uri="{9D8B030D-6E8A-4147-A177-3AD203B41FA5}">
                      <a16:colId xmlns:a16="http://schemas.microsoft.com/office/drawing/2014/main" val="3869019886"/>
                    </a:ext>
                  </a:extLst>
                </a:gridCol>
                <a:gridCol w="604800">
                  <a:extLst>
                    <a:ext uri="{9D8B030D-6E8A-4147-A177-3AD203B41FA5}">
                      <a16:colId xmlns:a16="http://schemas.microsoft.com/office/drawing/2014/main" val="1233056320"/>
                    </a:ext>
                  </a:extLst>
                </a:gridCol>
              </a:tblGrid>
              <a:tr h="408712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ene Name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C0C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old Change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C0C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EDGE Test P Value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C0C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haps Means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C0C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JAK1 Thaps Means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C0C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04481825"/>
                  </a:ext>
                </a:extLst>
              </a:tr>
              <a:tr h="139321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pr1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8.92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00000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9.98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.97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35867550"/>
                  </a:ext>
                </a:extLst>
              </a:tr>
              <a:tr h="139321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gs16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7.99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00000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0.63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.84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28856611"/>
                  </a:ext>
                </a:extLst>
              </a:tr>
              <a:tr h="139321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vd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7.64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00000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2.78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67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32312247"/>
                  </a:ext>
                </a:extLst>
              </a:tr>
              <a:tr h="139321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cl20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7.38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21485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.95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4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38609518"/>
                  </a:ext>
                </a:extLst>
              </a:tr>
              <a:tr h="139321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dm2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6.97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39063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.62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38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05218750"/>
                  </a:ext>
                </a:extLst>
              </a:tr>
              <a:tr h="139321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ldn9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5.83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00180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.93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36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25107590"/>
                  </a:ext>
                </a:extLst>
              </a:tr>
              <a:tr h="139321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tgs2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5.46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00002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3.84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.53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88246946"/>
                  </a:ext>
                </a:extLst>
              </a:tr>
              <a:tr h="139321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xnip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5.44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00000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8.52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8.12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64287434"/>
                  </a:ext>
                </a:extLst>
              </a:tr>
              <a:tr h="139321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uak2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4.83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00009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3.56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.81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44948465"/>
                  </a:ext>
                </a:extLst>
              </a:tr>
              <a:tr h="139321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rrdc4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4.73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00042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1.73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.48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71235214"/>
                  </a:ext>
                </a:extLst>
              </a:tr>
              <a:tr h="139321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lk2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4.41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00000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2.79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.17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77376138"/>
                  </a:ext>
                </a:extLst>
              </a:tr>
              <a:tr h="139321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gfbp3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4.33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00000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8.84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8.21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2040652"/>
                  </a:ext>
                </a:extLst>
              </a:tr>
              <a:tr h="139321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sad2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4.21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04077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.76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61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7174140"/>
                  </a:ext>
                </a:extLst>
              </a:tr>
              <a:tr h="139321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ist1h1d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3.89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00000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1.21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0.61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54169006"/>
                  </a:ext>
                </a:extLst>
              </a:tr>
              <a:tr h="139321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uak1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3.79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00014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4.31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.77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25192093"/>
                  </a:ext>
                </a:extLst>
              </a:tr>
              <a:tr h="139321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hbs1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3.58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00000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30.43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6.46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40464543"/>
                  </a:ext>
                </a:extLst>
              </a:tr>
              <a:tr h="139321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erl3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3.57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00222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2.5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.5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14114113"/>
                  </a:ext>
                </a:extLst>
              </a:tr>
              <a:tr h="139321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Ormdl2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3.51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00082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3.76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.92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74717597"/>
                  </a:ext>
                </a:extLst>
              </a:tr>
              <a:tr h="139321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upr1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3.46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00047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4.85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.29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36633332"/>
                  </a:ext>
                </a:extLst>
              </a:tr>
              <a:tr h="139321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fsd2a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3.41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00027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5.75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.61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06902867"/>
                  </a:ext>
                </a:extLst>
              </a:tr>
              <a:tr h="139321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cdc50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3.28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05925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.98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.13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63415064"/>
                  </a:ext>
                </a:extLst>
              </a:tr>
              <a:tr h="139321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cl7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3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16125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.43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.48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70973139"/>
                  </a:ext>
                </a:extLst>
              </a:tr>
              <a:tr h="139321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damts1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2.81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00000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12.13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9.94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10417639"/>
                  </a:ext>
                </a:extLst>
              </a:tr>
              <a:tr h="139321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am178a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2.7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00686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3.75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.09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46467027"/>
                  </a:ext>
                </a:extLst>
              </a:tr>
              <a:tr h="139321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sg15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2.58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00440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6.83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.51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93015511"/>
                  </a:ext>
                </a:extLst>
              </a:tr>
              <a:tr h="139321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dlbp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2.48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09476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.26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.74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7216364"/>
                  </a:ext>
                </a:extLst>
              </a:tr>
              <a:tr h="139321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Zfp260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2.47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03839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2.61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.11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21257199"/>
                  </a:ext>
                </a:extLst>
              </a:tr>
              <a:tr h="139321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em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2.41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00157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0.84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.65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46122221"/>
                  </a:ext>
                </a:extLst>
              </a:tr>
              <a:tr h="139321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cl2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2.37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00010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9.7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2.55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81846693"/>
                  </a:ext>
                </a:extLst>
              </a:tr>
              <a:tr h="139321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iga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2.24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06456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2.65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.64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59870380"/>
                  </a:ext>
                </a:extLst>
              </a:tr>
              <a:tr h="139321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Lrrc59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2.22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03690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4.86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.71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75375962"/>
                  </a:ext>
                </a:extLst>
              </a:tr>
              <a:tr h="139321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add45a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2.19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00000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16.63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3.34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50041454"/>
                  </a:ext>
                </a:extLst>
              </a:tr>
              <a:tr h="139321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lc30a1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2.07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00002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5.36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1.96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24726186"/>
                  </a:ext>
                </a:extLst>
              </a:tr>
              <a:tr h="139321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icd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2.03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16349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2.66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.24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90779212"/>
                  </a:ext>
                </a:extLst>
              </a:tr>
              <a:tr h="139321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df2l1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1.99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00000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10.27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5.29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44379901"/>
                  </a:ext>
                </a:extLst>
              </a:tr>
              <a:tr h="139321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Lgals3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1.99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39987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0.3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.18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13339387"/>
                  </a:ext>
                </a:extLst>
              </a:tr>
              <a:tr h="139321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tx3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1.99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11142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3.97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.03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03466583"/>
                  </a:ext>
                </a:extLst>
              </a:tr>
              <a:tr h="139321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ist1h1c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1.95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00000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63.47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38.25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45723023"/>
                  </a:ext>
                </a:extLst>
              </a:tr>
              <a:tr h="139321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yde1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1.92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12775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5.78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.21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92406500"/>
                  </a:ext>
                </a:extLst>
              </a:tr>
              <a:tr h="139321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fkb2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1.92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40225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1.93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.21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76670163"/>
                  </a:ext>
                </a:extLst>
              </a:tr>
              <a:tr h="139321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igd2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1.9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24747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2.72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.7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47136783"/>
                  </a:ext>
                </a:extLst>
              </a:tr>
              <a:tr h="139321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hmt2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1.72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03521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8.98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6.88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41961358"/>
                  </a:ext>
                </a:extLst>
              </a:tr>
              <a:tr h="139321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ist1h1b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1.7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00517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0.62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3.9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70641948"/>
                  </a:ext>
                </a:extLst>
              </a:tr>
              <a:tr h="139321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ec61a1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1.69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05684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8.17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6.69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88564937"/>
                  </a:ext>
                </a:extLst>
              </a:tr>
              <a:tr h="139321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Lbh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1.64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21088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2.58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3.77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5179970"/>
                  </a:ext>
                </a:extLst>
              </a:tr>
              <a:tr h="139321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you1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1.6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00002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8.54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1.59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85403695"/>
                  </a:ext>
                </a:extLst>
              </a:tr>
              <a:tr h="139321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rmcx3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1.54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19743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9.31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9.01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09009058"/>
                  </a:ext>
                </a:extLst>
              </a:tr>
              <a:tr h="139321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esn2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1.53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48237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0.69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3.53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92414373"/>
                  </a:ext>
                </a:extLst>
              </a:tr>
              <a:tr h="139321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zd8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1.52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25969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7.55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8.08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70486839"/>
                  </a:ext>
                </a:extLst>
              </a:tr>
              <a:tr h="139321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asn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1.51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11754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6.73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4.25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91909406"/>
                  </a:ext>
                </a:extLst>
              </a:tr>
              <a:tr h="139321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spyl2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1.5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35603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6.32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7.49</a:t>
                      </a:r>
                    </a:p>
                  </a:txBody>
                  <a:tcPr marL="4710" marR="4710" marT="47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36402995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35675329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103843"/>
            <a:ext cx="4047744" cy="2465832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482" y="891720"/>
            <a:ext cx="3977640" cy="245364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38709" y="891720"/>
            <a:ext cx="3973068" cy="245364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15849" y="3116035"/>
            <a:ext cx="3995928" cy="2453640"/>
          </a:xfrm>
          <a:prstGeom prst="rect">
            <a:avLst/>
          </a:prstGeom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D1325BBF-5C12-4C17-97AA-045E1D07FCE4}"/>
              </a:ext>
            </a:extLst>
          </p:cNvPr>
          <p:cNvSpPr/>
          <p:nvPr/>
        </p:nvSpPr>
        <p:spPr>
          <a:xfrm>
            <a:off x="226246" y="5581867"/>
            <a:ext cx="6858000" cy="76944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1000"/>
              </a:spcAft>
            </a:pP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l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100" b="1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: Confirmation that </a:t>
            </a:r>
            <a:r>
              <a:rPr lang="en-US" sz="11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TF4 is necessary for ER stress-induced gene </a:t>
            </a:r>
            <a:r>
              <a:rPr lang="en-US" sz="1100" b="1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xpression using a distinct ATF4-targeting siRNA. 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strocytes were transfected with control (CTL) or ATF4 siRNA #2 and treated with thaps (1 µM) for 4 h.  Gene expression was analyzed by </a:t>
            </a:r>
            <a:r>
              <a:rPr lang="en-US" sz="1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qRT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PCR. Data are represented as means ± standard deviation. N = 3. *p ≤ </a:t>
            </a:r>
            <a:r>
              <a:rPr lang="en-US" sz="11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0.05.</a:t>
            </a:r>
            <a:endParaRPr lang="en-US" sz="11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pic>
        <p:nvPicPr>
          <p:cNvPr id="11" name="Picture 10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956189" y="1130761"/>
            <a:ext cx="1459593" cy="574214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90E18CA6-3540-4CBA-86AD-70E5AC5AD462}"/>
              </a:ext>
            </a:extLst>
          </p:cNvPr>
          <p:cNvSpPr txBox="1"/>
          <p:nvPr/>
        </p:nvSpPr>
        <p:spPr>
          <a:xfrm>
            <a:off x="464941" y="334222"/>
            <a:ext cx="18133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l Figure 2. 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6741846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676399" y="3178524"/>
            <a:ext cx="3846576" cy="2859024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90E18CA6-3540-4CBA-86AD-70E5AC5AD462}"/>
              </a:ext>
            </a:extLst>
          </p:cNvPr>
          <p:cNvSpPr txBox="1"/>
          <p:nvPr/>
        </p:nvSpPr>
        <p:spPr>
          <a:xfrm>
            <a:off x="881501" y="2524718"/>
            <a:ext cx="18133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upplemental Figure 3. </a:t>
            </a: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D1325BBF-5C12-4C17-97AA-045E1D07FCE4}"/>
              </a:ext>
            </a:extLst>
          </p:cNvPr>
          <p:cNvSpPr/>
          <p:nvPr/>
        </p:nvSpPr>
        <p:spPr>
          <a:xfrm>
            <a:off x="564715" y="5944995"/>
            <a:ext cx="6858000" cy="93871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1000"/>
              </a:spcAft>
            </a:pP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3</a:t>
            </a:r>
            <a:r>
              <a:rPr lang="en-US" sz="11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: Subcellular markers for cytosolic and nuclear isolation. 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strocytes were transfected with control (CTL) or JAK1 siRNA #2 and treated with thaps (1 µM) for 4 h. Whole cell lysates, cytoplasmic, and nuclear fractions were isolated and immunoblotted for various subcellular markers. Transferrin receptor (</a:t>
            </a:r>
            <a:r>
              <a:rPr lang="en-US" sz="1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fR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 is a plasma membrane marker. Glyceraldehyde 3-phosphate dehydrogenase (GAPDH) is a cytoplasmic marker. Lysine-specific histone demethylase (LSD) 1 is a nuclear marker.</a:t>
            </a:r>
          </a:p>
        </p:txBody>
      </p:sp>
    </p:spTree>
    <p:extLst>
      <p:ext uri="{BB962C8B-B14F-4D97-AF65-F5344CB8AC3E}">
        <p14:creationId xmlns:p14="http://schemas.microsoft.com/office/powerpoint/2010/main" val="38591282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ip_UnifiedCompliancePolicyUIAction xmlns="http://schemas.microsoft.com/sharepoint/v3" xsi:nil="true"/>
    <_ip_UnifiedCompliancePolicyProperties xmlns="http://schemas.microsoft.com/sharepoint/v3" xsi:nil="true"/>
  </documentManagement>
</p:properti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DAD6CD34A1856049B66AB1658AAE4671" ma:contentTypeVersion="11" ma:contentTypeDescription="Create a new document." ma:contentTypeScope="" ma:versionID="bdfaf0fc0b876dbdd1e3aff4f7b661ed">
  <xsd:schema xmlns:xsd="http://www.w3.org/2001/XMLSchema" xmlns:xs="http://www.w3.org/2001/XMLSchema" xmlns:p="http://schemas.microsoft.com/office/2006/metadata/properties" xmlns:ns1="http://schemas.microsoft.com/sharepoint/v3" xmlns:ns2="675353e1-3a3c-4794-b840-62c0acae7884" xmlns:ns3="9eb323a1-896b-48f6-976f-7a0582ed60ff" targetNamespace="http://schemas.microsoft.com/office/2006/metadata/properties" ma:root="true" ma:fieldsID="8252049a3441e1f69328bf774c62c2db" ns1:_="" ns2:_="" ns3:_="">
    <xsd:import namespace="http://schemas.microsoft.com/sharepoint/v3"/>
    <xsd:import namespace="675353e1-3a3c-4794-b840-62c0acae7884"/>
    <xsd:import namespace="9eb323a1-896b-48f6-976f-7a0582ed60ff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1:_ip_UnifiedCompliancePolicyProperties" minOccurs="0"/>
                <xsd:element ref="ns1:_ip_UnifiedCompliancePolicyUIAction" minOccurs="0"/>
                <xsd:element ref="ns2:MediaServiceAutoTags" minOccurs="0"/>
                <xsd:element ref="ns2:MediaServiceOCR" minOccurs="0"/>
                <xsd:element ref="ns2:MediaServiceDateTaken" minOccurs="0"/>
                <xsd:element ref="ns2:MediaServiceEventHashCode" minOccurs="0"/>
                <xsd:element ref="ns2:MediaServiceGenerationTime" minOccurs="0"/>
                <xsd:element ref="ns3:SharedWithUsers" minOccurs="0"/>
                <xsd:element ref="ns3:SharedWithDetail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http://schemas.microsoft.com/sharepoint/v3" elementFormDefault="qualified">
    <xsd:import namespace="http://schemas.microsoft.com/office/2006/documentManagement/types"/>
    <xsd:import namespace="http://schemas.microsoft.com/office/infopath/2007/PartnerControls"/>
    <xsd:element name="_ip_UnifiedCompliancePolicyProperties" ma:index="10" nillable="true" ma:displayName="Unified Compliance Policy Properties" ma:hidden="true" ma:internalName="_ip_UnifiedCompliancePolicyProperties">
      <xsd:simpleType>
        <xsd:restriction base="dms:Note"/>
      </xsd:simpleType>
    </xsd:element>
    <xsd:element name="_ip_UnifiedCompliancePolicyUIAction" ma:index="11" nillable="true" ma:displayName="Unified Compliance Policy UI Action" ma:hidden="true" ma:internalName="_ip_UnifiedCompliancePolicyUIAction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675353e1-3a3c-4794-b840-62c0acae7884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2" nillable="true" ma:displayName="MediaServiceAutoTags" ma:internalName="MediaServiceAutoTags" ma:readOnly="true">
      <xsd:simpleType>
        <xsd:restriction base="dms:Text"/>
      </xsd:simpleType>
    </xsd:element>
    <xsd:element name="MediaServiceOCR" ma:index="13" nillable="true" ma:displayName="MediaServiceOCR" ma:internalName="MediaServiceOCR" ma:readOnly="true">
      <xsd:simpleType>
        <xsd:restriction base="dms:Note">
          <xsd:maxLength value="255"/>
        </xsd:restriction>
      </xsd:simpleType>
    </xsd:element>
    <xsd:element name="MediaServiceDateTaken" ma:index="14" nillable="true" ma:displayName="MediaServiceDateTaken" ma:hidden="true" ma:internalName="MediaServiceDateTaken" ma:readOnly="true">
      <xsd:simpleType>
        <xsd:restriction base="dms:Text"/>
      </xsd:simpleType>
    </xsd:element>
    <xsd:element name="MediaServiceEventHashCode" ma:index="15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GenerationTime" ma:index="16" nillable="true" ma:displayName="MediaServiceGenerationTime" ma:hidden="true" ma:internalName="MediaServiceGenerationTime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9eb323a1-896b-48f6-976f-7a0582ed60ff" elementFormDefault="qualified">
    <xsd:import namespace="http://schemas.microsoft.com/office/2006/documentManagement/types"/>
    <xsd:import namespace="http://schemas.microsoft.com/office/infopath/2007/PartnerControls"/>
    <xsd:element name="SharedWithUsers" ma:index="17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8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A56FC93A-798B-4E77-8B99-9DBD18430127}">
  <ds:schemaRefs>
    <ds:schemaRef ds:uri="http://schemas.microsoft.com/office/infopath/2007/PartnerControls"/>
    <ds:schemaRef ds:uri="http://schemas.openxmlformats.org/package/2006/metadata/core-properties"/>
    <ds:schemaRef ds:uri="9eb323a1-896b-48f6-976f-7a0582ed60ff"/>
    <ds:schemaRef ds:uri="http://schemas.microsoft.com/office/2006/metadata/properties"/>
    <ds:schemaRef ds:uri="http://www.w3.org/XML/1998/namespace"/>
    <ds:schemaRef ds:uri="http://schemas.microsoft.com/office/2006/documentManagement/types"/>
    <ds:schemaRef ds:uri="http://schemas.microsoft.com/sharepoint/v3"/>
    <ds:schemaRef ds:uri="http://purl.org/dc/dcmitype/"/>
    <ds:schemaRef ds:uri="675353e1-3a3c-4794-b840-62c0acae7884"/>
    <ds:schemaRef ds:uri="http://purl.org/dc/terms/"/>
    <ds:schemaRef ds:uri="http://purl.org/dc/elements/1.1/"/>
  </ds:schemaRefs>
</ds:datastoreItem>
</file>

<file path=customXml/itemProps2.xml><?xml version="1.0" encoding="utf-8"?>
<ds:datastoreItem xmlns:ds="http://schemas.openxmlformats.org/officeDocument/2006/customXml" ds:itemID="{49DC0C55-1B79-4ABF-B546-D98D37536A63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http://schemas.microsoft.com/sharepoint/v3"/>
    <ds:schemaRef ds:uri="675353e1-3a3c-4794-b840-62c0acae7884"/>
    <ds:schemaRef ds:uri="9eb323a1-896b-48f6-976f-7a0582ed60ff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49839D43-F6DC-4008-A1F6-27713E6E1B73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94935</TotalTime>
  <Words>806</Words>
  <Application>Microsoft Office PowerPoint</Application>
  <PresentationFormat>Custom</PresentationFormat>
  <Paragraphs>525</Paragraphs>
  <Slides>3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6" baseType="lpstr">
      <vt:lpstr>Arial</vt:lpstr>
      <vt:lpstr>Calibri</vt:lpstr>
      <vt:lpstr>Office Them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eares, Gordon</dc:creator>
  <cp:lastModifiedBy>Savannah Sims</cp:lastModifiedBy>
  <cp:revision>367</cp:revision>
  <cp:lastPrinted>2019-05-21T15:13:18Z</cp:lastPrinted>
  <dcterms:modified xsi:type="dcterms:W3CDTF">2019-06-05T13:50:3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DAD6CD34A1856049B66AB1658AAE4671</vt:lpwstr>
  </property>
</Properties>
</file>